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3.xml" ContentType="application/vnd.ms-office.chartcolor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70" r:id="rId2"/>
    <p:sldId id="372" r:id="rId3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80" autoAdjust="0"/>
    <p:restoredTop sz="92791" autoAdjust="0"/>
  </p:normalViewPr>
  <p:slideViewPr>
    <p:cSldViewPr>
      <p:cViewPr varScale="1">
        <p:scale>
          <a:sx n="117" d="100"/>
          <a:sy n="117" d="100"/>
        </p:scale>
        <p:origin x="-158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$2:$N$2</c:f>
                <c:numCache>
                  <c:formatCode>General</c:formatCode>
                  <c:ptCount val="14"/>
                  <c:pt idx="0">
                    <c:v>3.7290000000000001E-3</c:v>
                  </c:pt>
                  <c:pt idx="1">
                    <c:v>1.4558E-2</c:v>
                  </c:pt>
                  <c:pt idx="2">
                    <c:v>3.6459999999999999E-3</c:v>
                  </c:pt>
                  <c:pt idx="3">
                    <c:v>3.869E-3</c:v>
                  </c:pt>
                  <c:pt idx="4">
                    <c:v>7.012E-3</c:v>
                  </c:pt>
                  <c:pt idx="5">
                    <c:v>4.7676999999999997E-2</c:v>
                  </c:pt>
                  <c:pt idx="6">
                    <c:v>1.3429E-2</c:v>
                  </c:pt>
                  <c:pt idx="7">
                    <c:v>1.4651000000000001E-2</c:v>
                  </c:pt>
                  <c:pt idx="8">
                    <c:v>1.2460000000000001E-2</c:v>
                  </c:pt>
                  <c:pt idx="9">
                    <c:v>1.4378999999999999E-2</c:v>
                  </c:pt>
                  <c:pt idx="10">
                    <c:v>2.4680000000000001E-3</c:v>
                  </c:pt>
                  <c:pt idx="11">
                    <c:v>8.4860000000000005E-3</c:v>
                  </c:pt>
                  <c:pt idx="12">
                    <c:v>1.6233999999999998E-2</c:v>
                  </c:pt>
                  <c:pt idx="13">
                    <c:v>4.10070000000000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$1:$N$1</c:f>
              <c:numCache>
                <c:formatCode>General</c:formatCode>
                <c:ptCount val="14"/>
                <c:pt idx="0">
                  <c:v>0.13053300000000001</c:v>
                </c:pt>
                <c:pt idx="1">
                  <c:v>0.150867</c:v>
                </c:pt>
                <c:pt idx="2">
                  <c:v>0.130333</c:v>
                </c:pt>
                <c:pt idx="3">
                  <c:v>0.1203</c:v>
                </c:pt>
                <c:pt idx="4">
                  <c:v>0.116067</c:v>
                </c:pt>
                <c:pt idx="5">
                  <c:v>0.191667</c:v>
                </c:pt>
                <c:pt idx="6">
                  <c:v>0.171733</c:v>
                </c:pt>
                <c:pt idx="7">
                  <c:v>0.16996700000000001</c:v>
                </c:pt>
                <c:pt idx="8">
                  <c:v>0.15426699999999999</c:v>
                </c:pt>
                <c:pt idx="9">
                  <c:v>0.15376699999999999</c:v>
                </c:pt>
                <c:pt idx="10">
                  <c:v>0.14353299999999999</c:v>
                </c:pt>
                <c:pt idx="11">
                  <c:v>0.20230000000000001</c:v>
                </c:pt>
                <c:pt idx="12">
                  <c:v>0.21046699999999999</c:v>
                </c:pt>
                <c:pt idx="13">
                  <c:v>0.231167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438528"/>
        <c:axId val="34440320"/>
      </c:barChart>
      <c:catAx>
        <c:axId val="344385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440320"/>
        <c:crosses val="autoZero"/>
        <c:auto val="1"/>
        <c:lblAlgn val="ctr"/>
        <c:lblOffset val="100"/>
        <c:noMultiLvlLbl val="0"/>
      </c:catAx>
      <c:valAx>
        <c:axId val="34440320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43852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r">
              <a:defRPr sz="1200"/>
            </a:lvl1pPr>
          </a:lstStyle>
          <a:p>
            <a:fld id="{A9AA63FC-A05E-428B-B976-FF78AC99CCAC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1233488"/>
            <a:ext cx="4440237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4" tIns="45706" rIns="91414" bIns="4570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21"/>
            <a:ext cx="5393690" cy="3887361"/>
          </a:xfrm>
          <a:prstGeom prst="rect">
            <a:avLst/>
          </a:prstGeom>
        </p:spPr>
        <p:txBody>
          <a:bodyPr vert="horz" lIns="91414" tIns="45706" rIns="91414" bIns="45706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r">
              <a:defRPr sz="1200"/>
            </a:lvl1pPr>
          </a:lstStyle>
          <a:p>
            <a:fld id="{61E1D6D5-554B-4C80-83C5-D1FA752FB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643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/>
          </p:nvPr>
        </p:nvGraphicFramePr>
        <p:xfrm>
          <a:off x="1463040" y="1181686"/>
          <a:ext cx="6668086" cy="42625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 rot="16200000">
            <a:off x="-498715" y="2958997"/>
            <a:ext cx="309251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Biofilm formation</a:t>
            </a:r>
          </a:p>
          <a:p>
            <a:pPr algn="ctr"/>
            <a:r>
              <a:rPr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bsorbance at 492 nm)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7613949" y="5234896"/>
            <a:ext cx="33855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219123" y="5234896"/>
            <a:ext cx="26161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781615" y="5232548"/>
            <a:ext cx="37702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320181" y="5232548"/>
            <a:ext cx="45397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924545" y="5235357"/>
            <a:ext cx="45397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3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516987" y="5232548"/>
            <a:ext cx="45397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091920" y="5228009"/>
            <a:ext cx="45397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700985" y="5225739"/>
            <a:ext cx="37702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262903" y="5223470"/>
            <a:ext cx="45878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/20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843339" y="5227560"/>
            <a:ext cx="45878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/40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447703" y="5232548"/>
            <a:ext cx="45878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/80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998825" y="5232548"/>
            <a:ext cx="53572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/160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547496" y="5232548"/>
            <a:ext cx="53572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/320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266343" y="5223470"/>
            <a:ext cx="26161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648448" y="5627077"/>
            <a:ext cx="29308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aluronic acid (mg/ ml)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440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259632" y="2348880"/>
            <a:ext cx="6858000" cy="30008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film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mation of </a:t>
            </a:r>
            <a:r>
              <a:rPr lang="en-GB" altLang="ja-JP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tfBC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utant was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ly assessed in conditions with various concentrations of </a:t>
            </a:r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alurobic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ids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human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iva-coated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-well </a:t>
            </a:r>
            <a:r>
              <a:rPr lang="en-GB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titre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tes in TSB with 0.25% sucrose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an ±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iplicate experiments. The independent experiments were performed 3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s, with similar results obtained in each.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aluronic acid did not have abilities to induce the biofilm formation of </a:t>
            </a:r>
            <a:r>
              <a:rPr lang="en-US" altLang="ja-JP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ja-JP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043608" y="908720"/>
            <a:ext cx="76328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.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ffects of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aluronic acid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film formation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0599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96</TotalTime>
  <Words>114</Words>
  <Application>Microsoft Office PowerPoint</Application>
  <PresentationFormat>On-screen Show (4:3)</PresentationFormat>
  <Paragraphs>1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Company>FJ-US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片岡清子</dc:creator>
  <cp:lastModifiedBy>Guna Sankar</cp:lastModifiedBy>
  <cp:revision>215</cp:revision>
  <cp:lastPrinted>2018-04-13T06:44:23Z</cp:lastPrinted>
  <dcterms:created xsi:type="dcterms:W3CDTF">2016-06-03T10:32:30Z</dcterms:created>
  <dcterms:modified xsi:type="dcterms:W3CDTF">2019-11-14T11:34:23Z</dcterms:modified>
</cp:coreProperties>
</file>